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9"/>
  </p:notesMasterIdLst>
  <p:sldIdLst>
    <p:sldId id="414" r:id="rId2"/>
    <p:sldId id="415" r:id="rId3"/>
    <p:sldId id="416" r:id="rId4"/>
    <p:sldId id="410" r:id="rId5"/>
    <p:sldId id="417" r:id="rId6"/>
    <p:sldId id="418" r:id="rId7"/>
    <p:sldId id="419" r:id="rId8"/>
  </p:sldIdLst>
  <p:sldSz cx="8280400" cy="12192000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 snapToGrid="0">
      <p:cViewPr>
        <p:scale>
          <a:sx n="80" d="100"/>
          <a:sy n="80" d="100"/>
        </p:scale>
        <p:origin x="-1632" y="782"/>
      </p:cViewPr>
      <p:guideLst>
        <p:guide orient="horz" pos="3840"/>
        <p:guide pos="260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94DD19-88DE-4427-B943-D7AC981D1C84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76488" y="1279525"/>
            <a:ext cx="234632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67EB48-4F53-4D75-8E18-EB62A715F6C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0068678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67EB48-4F53-4D75-8E18-EB62A715F6C8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5045516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167EB48-4F53-4D75-8E18-EB62A715F6C8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0" y="1995312"/>
            <a:ext cx="7038340" cy="4244622"/>
          </a:xfrm>
        </p:spPr>
        <p:txBody>
          <a:bodyPr anchor="b"/>
          <a:lstStyle>
            <a:lvl1pPr algn="ctr">
              <a:defRPr sz="54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0" y="6403623"/>
            <a:ext cx="6210300" cy="2943577"/>
          </a:xfrm>
        </p:spPr>
        <p:txBody>
          <a:bodyPr/>
          <a:lstStyle>
            <a:lvl1pPr marL="0" indent="0" algn="ctr">
              <a:buNone/>
              <a:defRPr sz="2173"/>
            </a:lvl1pPr>
            <a:lvl2pPr marL="414040" indent="0" algn="ctr">
              <a:buNone/>
              <a:defRPr sz="1811"/>
            </a:lvl2pPr>
            <a:lvl3pPr marL="828081" indent="0" algn="ctr">
              <a:buNone/>
              <a:defRPr sz="1630"/>
            </a:lvl3pPr>
            <a:lvl4pPr marL="1242121" indent="0" algn="ctr">
              <a:buNone/>
              <a:defRPr sz="1449"/>
            </a:lvl4pPr>
            <a:lvl5pPr marL="1656161" indent="0" algn="ctr">
              <a:buNone/>
              <a:defRPr sz="1449"/>
            </a:lvl5pPr>
            <a:lvl6pPr marL="2070202" indent="0" algn="ctr">
              <a:buNone/>
              <a:defRPr sz="1449"/>
            </a:lvl6pPr>
            <a:lvl7pPr marL="2484242" indent="0" algn="ctr">
              <a:buNone/>
              <a:defRPr sz="1449"/>
            </a:lvl7pPr>
            <a:lvl8pPr marL="2898282" indent="0" algn="ctr">
              <a:buNone/>
              <a:defRPr sz="1449"/>
            </a:lvl8pPr>
            <a:lvl9pPr marL="3312323" indent="0" algn="ctr">
              <a:buNone/>
              <a:defRPr sz="1449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503267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665175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2" y="649111"/>
            <a:ext cx="1785461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8" y="649111"/>
            <a:ext cx="5252879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398013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902638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5" y="3039537"/>
            <a:ext cx="7141845" cy="5071532"/>
          </a:xfrm>
        </p:spPr>
        <p:txBody>
          <a:bodyPr anchor="b"/>
          <a:lstStyle>
            <a:lvl1pPr>
              <a:defRPr sz="543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5" y="8159048"/>
            <a:ext cx="7141845" cy="2666999"/>
          </a:xfrm>
        </p:spPr>
        <p:txBody>
          <a:bodyPr/>
          <a:lstStyle>
            <a:lvl1pPr marL="0" indent="0">
              <a:buNone/>
              <a:defRPr sz="2173">
                <a:solidFill>
                  <a:schemeClr val="tx1"/>
                </a:solidFill>
              </a:defRPr>
            </a:lvl1pPr>
            <a:lvl2pPr marL="414040" indent="0">
              <a:buNone/>
              <a:defRPr sz="1811">
                <a:solidFill>
                  <a:schemeClr val="tx1">
                    <a:tint val="75000"/>
                  </a:schemeClr>
                </a:solidFill>
              </a:defRPr>
            </a:lvl2pPr>
            <a:lvl3pPr marL="82808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3pPr>
            <a:lvl4pPr marL="124212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4pPr>
            <a:lvl5pPr marL="165616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5pPr>
            <a:lvl6pPr marL="207020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6pPr>
            <a:lvl7pPr marL="248424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7pPr>
            <a:lvl8pPr marL="289828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8pPr>
            <a:lvl9pPr marL="3312323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670060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3245556"/>
            <a:ext cx="351917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3245556"/>
            <a:ext cx="351917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897568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649114"/>
            <a:ext cx="714184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7" y="2988734"/>
            <a:ext cx="3502997" cy="1464732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7" y="4453467"/>
            <a:ext cx="3502997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3" y="2988734"/>
            <a:ext cx="3520249" cy="1464732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3" y="4453467"/>
            <a:ext cx="3520249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227933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460035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646407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812800"/>
            <a:ext cx="2670645" cy="2844800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8" y="1755425"/>
            <a:ext cx="4191953" cy="8664222"/>
          </a:xfrm>
        </p:spPr>
        <p:txBody>
          <a:bodyPr/>
          <a:lstStyle>
            <a:lvl1pPr>
              <a:defRPr sz="2898"/>
            </a:lvl1pPr>
            <a:lvl2pPr>
              <a:defRPr sz="2536"/>
            </a:lvl2pPr>
            <a:lvl3pPr>
              <a:defRPr sz="2173"/>
            </a:lvl3pPr>
            <a:lvl4pPr>
              <a:defRPr sz="1811"/>
            </a:lvl4pPr>
            <a:lvl5pPr>
              <a:defRPr sz="1811"/>
            </a:lvl5pPr>
            <a:lvl6pPr>
              <a:defRPr sz="1811"/>
            </a:lvl6pPr>
            <a:lvl7pPr>
              <a:defRPr sz="1811"/>
            </a:lvl7pPr>
            <a:lvl8pPr>
              <a:defRPr sz="1811"/>
            </a:lvl8pPr>
            <a:lvl9pPr>
              <a:defRPr sz="181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3657600"/>
            <a:ext cx="2670645" cy="6776156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9228594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812800"/>
            <a:ext cx="2670645" cy="2844800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8" y="1755425"/>
            <a:ext cx="4191953" cy="8664222"/>
          </a:xfrm>
        </p:spPr>
        <p:txBody>
          <a:bodyPr anchor="t"/>
          <a:lstStyle>
            <a:lvl1pPr marL="0" indent="0">
              <a:buNone/>
              <a:defRPr sz="2898"/>
            </a:lvl1pPr>
            <a:lvl2pPr marL="414040" indent="0">
              <a:buNone/>
              <a:defRPr sz="2536"/>
            </a:lvl2pPr>
            <a:lvl3pPr marL="828081" indent="0">
              <a:buNone/>
              <a:defRPr sz="2173"/>
            </a:lvl3pPr>
            <a:lvl4pPr marL="1242121" indent="0">
              <a:buNone/>
              <a:defRPr sz="1811"/>
            </a:lvl4pPr>
            <a:lvl5pPr marL="1656161" indent="0">
              <a:buNone/>
              <a:defRPr sz="1811"/>
            </a:lvl5pPr>
            <a:lvl6pPr marL="2070202" indent="0">
              <a:buNone/>
              <a:defRPr sz="1811"/>
            </a:lvl6pPr>
            <a:lvl7pPr marL="2484242" indent="0">
              <a:buNone/>
              <a:defRPr sz="1811"/>
            </a:lvl7pPr>
            <a:lvl8pPr marL="2898282" indent="0">
              <a:buNone/>
              <a:defRPr sz="1811"/>
            </a:lvl8pPr>
            <a:lvl9pPr marL="3312323" indent="0">
              <a:buNone/>
              <a:defRPr sz="1811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3657600"/>
            <a:ext cx="2670645" cy="6776156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008699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649114"/>
            <a:ext cx="714184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3245556"/>
            <a:ext cx="714184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8" y="11300181"/>
            <a:ext cx="18630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F531D-E7F2-442D-BE08-50C1E1025CFD}" type="datetimeFigureOut">
              <a:rPr lang="zh-CN" altLang="en-US" smtClean="0"/>
              <a:pPr/>
              <a:t>2022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11300181"/>
            <a:ext cx="279463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11300181"/>
            <a:ext cx="186309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244A0-8D08-49E7-BB10-6485F4FF2D1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473122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828081" rtl="0" eaLnBrk="1" latinLnBrk="0" hangingPunct="1">
        <a:lnSpc>
          <a:spcPct val="90000"/>
        </a:lnSpc>
        <a:spcBef>
          <a:spcPct val="0"/>
        </a:spcBef>
        <a:buNone/>
        <a:defRPr sz="39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7020" indent="-207020" algn="l" defTabSz="828081" rtl="0" eaLnBrk="1" latinLnBrk="0" hangingPunct="1">
        <a:lnSpc>
          <a:spcPct val="90000"/>
        </a:lnSpc>
        <a:spcBef>
          <a:spcPts val="906"/>
        </a:spcBef>
        <a:buFont typeface="Arial" panose="020B0604020202020204" pitchFamily="34" charset="0"/>
        <a:buChar char="•"/>
        <a:defRPr sz="2536" kern="1200">
          <a:solidFill>
            <a:schemeClr val="tx1"/>
          </a:solidFill>
          <a:latin typeface="+mn-lt"/>
          <a:ea typeface="+mn-ea"/>
          <a:cs typeface="+mn-cs"/>
        </a:defRPr>
      </a:lvl1pPr>
      <a:lvl2pPr marL="621060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03510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811" kern="1200">
          <a:solidFill>
            <a:schemeClr val="tx1"/>
          </a:solidFill>
          <a:latin typeface="+mn-lt"/>
          <a:ea typeface="+mn-ea"/>
          <a:cs typeface="+mn-cs"/>
        </a:defRPr>
      </a:lvl3pPr>
      <a:lvl4pPr marL="144914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86318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27722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69126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310530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519343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1pPr>
      <a:lvl2pPr marL="41404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2pPr>
      <a:lvl3pPr marL="82808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3pPr>
      <a:lvl4pPr marL="124212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65616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07020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48424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289828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312323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9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="" xmlns:a16="http://schemas.microsoft.com/office/drawing/2014/main" id="{BA53F38C-699C-597B-F836-CCC6C8A4C1FE}"/>
              </a:ext>
            </a:extLst>
          </p:cNvPr>
          <p:cNvSpPr txBox="1"/>
          <p:nvPr/>
        </p:nvSpPr>
        <p:spPr>
          <a:xfrm>
            <a:off x="356688" y="5926173"/>
            <a:ext cx="7726946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igure </a:t>
            </a:r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S1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T-qPCR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tection of relative expression of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gene in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s and complementa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trains.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Values are the means (±SE) based on three independent experiments and bars indicate standard deviations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he letters above the bars are significantly different at 0.05 level using Duncan’ s multiple range test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/>
          <a:srcRect l="8440" t="6438" r="10944" b="5720"/>
          <a:stretch>
            <a:fillRect/>
          </a:stretch>
        </p:blipFill>
        <p:spPr bwMode="auto">
          <a:xfrm>
            <a:off x="2085975" y="2695575"/>
            <a:ext cx="3790950" cy="31623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="" xmlns:p14="http://schemas.microsoft.com/office/powerpoint/2010/main" val="8954727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2CE96B1C-D3B3-18BA-D6C8-12647F71860D}"/>
              </a:ext>
            </a:extLst>
          </p:cNvPr>
          <p:cNvSpPr txBox="1"/>
          <p:nvPr/>
        </p:nvSpPr>
        <p:spPr>
          <a:xfrm>
            <a:off x="641677" y="4785894"/>
            <a:ext cx="7122694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igure </a:t>
            </a:r>
            <a:r>
              <a:rPr lang="en-US" altLang="zh-CN" sz="1600" b="1" kern="0" dirty="0" smtClean="0"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S2</a:t>
            </a:r>
            <a:r>
              <a:rPr lang="en-US" altLang="zh-CN" sz="1600" kern="0" dirty="0" smtClean="0"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lony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orphology of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deletion mutants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nd complementa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trains.</a:t>
            </a:r>
            <a:endParaRPr lang="en-US" altLang="zh-CN" sz="1600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c TR4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the wide-type strain; </a:t>
            </a:r>
            <a:r>
              <a:rPr lang="zh-CN" altLang="en-US" sz="1600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9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zh-CN" altLang="en-US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zh-CN" altLang="en-US" sz="16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20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s; </a:t>
            </a:r>
            <a:r>
              <a:rPr lang="zh-CN" altLang="en-US" sz="1600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</a:t>
            </a:r>
            <a:r>
              <a:rPr lang="en-US" altLang="zh-CN" sz="1600" i="1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-9-com </a:t>
            </a:r>
            <a:r>
              <a:rPr lang="en-US" altLang="zh-CN" sz="1600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and </a:t>
            </a:r>
            <a:r>
              <a:rPr lang="zh-CN" altLang="en-US" sz="1600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</a:t>
            </a:r>
            <a:r>
              <a:rPr lang="en-US" altLang="zh-CN" sz="1600" i="1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-15-com</a:t>
            </a:r>
            <a:r>
              <a:rPr lang="en-US" altLang="zh-CN" sz="1600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,  </a:t>
            </a:r>
            <a:r>
              <a:rPr lang="en-US" altLang="zh-CN" sz="1600" i="1" kern="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mplementa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strains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Images were taken at 5 dpi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文本框 12">
            <a:extLst>
              <a:ext uri="{FF2B5EF4-FFF2-40B4-BE49-F238E27FC236}">
                <a16:creationId xmlns="" xmlns:a16="http://schemas.microsoft.com/office/drawing/2014/main" id="{5D22D548-B932-CB8E-CF12-2AE2C2B5FC78}"/>
              </a:ext>
            </a:extLst>
          </p:cNvPr>
          <p:cNvSpPr txBox="1"/>
          <p:nvPr/>
        </p:nvSpPr>
        <p:spPr>
          <a:xfrm>
            <a:off x="465923" y="2409332"/>
            <a:ext cx="6953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 medium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4">
            <a:extLst>
              <a:ext uri="{FF2B5EF4-FFF2-40B4-BE49-F238E27FC236}">
                <a16:creationId xmlns="" xmlns:a16="http://schemas.microsoft.com/office/drawing/2014/main" id="{2D903BCA-A64F-3664-04BD-B4031A6C3485}"/>
              </a:ext>
            </a:extLst>
          </p:cNvPr>
          <p:cNvSpPr txBox="1"/>
          <p:nvPr/>
        </p:nvSpPr>
        <p:spPr>
          <a:xfrm>
            <a:off x="1203695" y="1624563"/>
            <a:ext cx="7775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c TR4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5">
            <a:extLst>
              <a:ext uri="{FF2B5EF4-FFF2-40B4-BE49-F238E27FC236}">
                <a16:creationId xmlns="" xmlns:a16="http://schemas.microsoft.com/office/drawing/2014/main" id="{79336E0C-4341-9B7E-6E75-186E0F8BB109}"/>
              </a:ext>
            </a:extLst>
          </p:cNvPr>
          <p:cNvSpPr txBox="1"/>
          <p:nvPr/>
        </p:nvSpPr>
        <p:spPr>
          <a:xfrm>
            <a:off x="3248533" y="1641376"/>
            <a:ext cx="12750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upin1-15</a:t>
            </a:r>
            <a:endParaRPr lang="zh-CN" altLang="en-US" sz="1200" i="1" dirty="0"/>
          </a:p>
        </p:txBody>
      </p:sp>
      <p:sp>
        <p:nvSpPr>
          <p:cNvPr id="31" name="文本框 7">
            <a:extLst>
              <a:ext uri="{FF2B5EF4-FFF2-40B4-BE49-F238E27FC236}">
                <a16:creationId xmlns="" xmlns:a16="http://schemas.microsoft.com/office/drawing/2014/main" id="{8B3D4B68-73EB-6CC5-F22E-B2627DC15BED}"/>
              </a:ext>
            </a:extLst>
          </p:cNvPr>
          <p:cNvSpPr txBox="1"/>
          <p:nvPr/>
        </p:nvSpPr>
        <p:spPr>
          <a:xfrm>
            <a:off x="2130239" y="1622326"/>
            <a:ext cx="11646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upin1-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9</a:t>
            </a:r>
            <a:endParaRPr lang="zh-CN" altLang="en-US" sz="1200" dirty="0"/>
          </a:p>
        </p:txBody>
      </p:sp>
      <p:sp>
        <p:nvSpPr>
          <p:cNvPr id="38" name="文本框 16">
            <a:extLst>
              <a:ext uri="{FF2B5EF4-FFF2-40B4-BE49-F238E27FC236}">
                <a16:creationId xmlns="" xmlns:a16="http://schemas.microsoft.com/office/drawing/2014/main" id="{2B1FAFBC-2FEB-2D83-3F38-2FB524A0D709}"/>
              </a:ext>
            </a:extLst>
          </p:cNvPr>
          <p:cNvSpPr txBox="1"/>
          <p:nvPr/>
        </p:nvSpPr>
        <p:spPr>
          <a:xfrm>
            <a:off x="404292" y="3301757"/>
            <a:ext cx="8045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</a:t>
            </a:r>
          </a:p>
          <a:p>
            <a:pPr algn="ctr"/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dium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5">
            <a:extLst>
              <a:ext uri="{FF2B5EF4-FFF2-40B4-BE49-F238E27FC236}">
                <a16:creationId xmlns="" xmlns:a16="http://schemas.microsoft.com/office/drawing/2014/main" id="{79336E0C-4341-9B7E-6E75-186E0F8BB109}"/>
              </a:ext>
            </a:extLst>
          </p:cNvPr>
          <p:cNvSpPr txBox="1"/>
          <p:nvPr/>
        </p:nvSpPr>
        <p:spPr>
          <a:xfrm>
            <a:off x="4382008" y="1650901"/>
            <a:ext cx="127503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upin1-20</a:t>
            </a:r>
            <a:endParaRPr lang="zh-CN" altLang="en-US" sz="1200" dirty="0"/>
          </a:p>
        </p:txBody>
      </p:sp>
      <p:sp>
        <p:nvSpPr>
          <p:cNvPr id="44" name="文本框 5">
            <a:extLst>
              <a:ext uri="{FF2B5EF4-FFF2-40B4-BE49-F238E27FC236}">
                <a16:creationId xmlns="" xmlns:a16="http://schemas.microsoft.com/office/drawing/2014/main" id="{79336E0C-4341-9B7E-6E75-186E0F8BB109}"/>
              </a:ext>
            </a:extLst>
          </p:cNvPr>
          <p:cNvSpPr txBox="1"/>
          <p:nvPr/>
        </p:nvSpPr>
        <p:spPr>
          <a:xfrm>
            <a:off x="5438774" y="1641376"/>
            <a:ext cx="14573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upin1-9-com</a:t>
            </a:r>
            <a:endParaRPr lang="zh-CN" altLang="en-US" sz="1200" dirty="0"/>
          </a:p>
        </p:txBody>
      </p:sp>
      <p:pic>
        <p:nvPicPr>
          <p:cNvPr id="1026" name="Picture 2" descr="C:\Users\yunfengli\Desktop\Figure S2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063625" y="1887538"/>
            <a:ext cx="5632450" cy="2240121"/>
          </a:xfrm>
          <a:prstGeom prst="rect">
            <a:avLst/>
          </a:prstGeom>
          <a:noFill/>
        </p:spPr>
      </p:pic>
      <p:pic>
        <p:nvPicPr>
          <p:cNvPr id="27" name="图片 26">
            <a:extLst>
              <a:ext uri="{FF2B5EF4-FFF2-40B4-BE49-F238E27FC236}">
                <a16:creationId xmlns="" xmlns:a16="http://schemas.microsoft.com/office/drawing/2014/main" id="{0B649E75-8927-55DD-46C6-FF9202A4AFD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/>
          <a:srcRect l="31421" t="23567" r="23703" b="8491"/>
          <a:stretch/>
        </p:blipFill>
        <p:spPr>
          <a:xfrm>
            <a:off x="6725117" y="1898739"/>
            <a:ext cx="1101100" cy="1080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="" xmlns:a16="http://schemas.microsoft.com/office/drawing/2014/main" id="{4E2D91A9-2FD8-ABF8-86BC-871FA06F610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/>
          <a:srcRect l="25926" t="26077" r="29815" b="8486"/>
          <a:stretch/>
        </p:blipFill>
        <p:spPr>
          <a:xfrm>
            <a:off x="6725564" y="3038289"/>
            <a:ext cx="1093680" cy="1080000"/>
          </a:xfrm>
          <a:prstGeom prst="rect">
            <a:avLst/>
          </a:prstGeom>
        </p:spPr>
      </p:pic>
      <p:sp>
        <p:nvSpPr>
          <p:cNvPr id="33" name="文本框 5">
            <a:extLst>
              <a:ext uri="{FF2B5EF4-FFF2-40B4-BE49-F238E27FC236}">
                <a16:creationId xmlns="" xmlns:a16="http://schemas.microsoft.com/office/drawing/2014/main" id="{79336E0C-4341-9B7E-6E75-186E0F8BB109}"/>
              </a:ext>
            </a:extLst>
          </p:cNvPr>
          <p:cNvSpPr txBox="1"/>
          <p:nvPr/>
        </p:nvSpPr>
        <p:spPr>
          <a:xfrm>
            <a:off x="6677534" y="1641376"/>
            <a:ext cx="16028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upin1-15-com</a:t>
            </a:r>
            <a:endParaRPr lang="zh-CN" altLang="en-US" sz="1200" dirty="0"/>
          </a:p>
        </p:txBody>
      </p:sp>
    </p:spTree>
    <p:extLst>
      <p:ext uri="{BB962C8B-B14F-4D97-AF65-F5344CB8AC3E}">
        <p14:creationId xmlns="" xmlns:p14="http://schemas.microsoft.com/office/powerpoint/2010/main" val="1920733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26">
            <a:extLst>
              <a:ext uri="{FF2B5EF4-FFF2-40B4-BE49-F238E27FC236}">
                <a16:creationId xmlns="" xmlns:a16="http://schemas.microsoft.com/office/drawing/2014/main" id="{FCB7BE4F-94AD-44C9-8717-8F8C8A94F5C8}"/>
              </a:ext>
            </a:extLst>
          </p:cNvPr>
          <p:cNvGrpSpPr/>
          <p:nvPr/>
        </p:nvGrpSpPr>
        <p:grpSpPr>
          <a:xfrm>
            <a:off x="2297999" y="1390649"/>
            <a:ext cx="3498830" cy="3202030"/>
            <a:chOff x="239367" y="1327587"/>
            <a:chExt cx="3498830" cy="3202030"/>
          </a:xfrm>
        </p:grpSpPr>
        <p:pic>
          <p:nvPicPr>
            <p:cNvPr id="3" name="图片 2">
              <a:extLst>
                <a:ext uri="{FF2B5EF4-FFF2-40B4-BE49-F238E27FC236}">
                  <a16:creationId xmlns="" xmlns:a16="http://schemas.microsoft.com/office/drawing/2014/main" id="{912BB347-0FD7-480F-B183-9268B9594C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="" xmlns:a14="http://schemas.microsoft.com/office/drawing/2010/main">
                    <a14:imgLayer r:embed="rId3">
                      <a14:imgEffect>
                        <a14:brightnessContrast bright="28000" contrast="34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33303" y="2792995"/>
              <a:ext cx="2904894" cy="1736622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="" xmlns:a16="http://schemas.microsoft.com/office/drawing/2014/main" id="{1BDAA664-0D2A-42EF-9FF1-6363256E999B}"/>
                </a:ext>
              </a:extLst>
            </p:cNvPr>
            <p:cNvSpPr txBox="1"/>
            <p:nvPr/>
          </p:nvSpPr>
          <p:spPr>
            <a:xfrm>
              <a:off x="239367" y="2981201"/>
              <a:ext cx="7677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0 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="" xmlns:a16="http://schemas.microsoft.com/office/drawing/2014/main" id="{665309CF-680B-4211-A0A2-F4578023F200}"/>
                </a:ext>
              </a:extLst>
            </p:cNvPr>
            <p:cNvSpPr txBox="1"/>
            <p:nvPr/>
          </p:nvSpPr>
          <p:spPr>
            <a:xfrm rot="16200000">
              <a:off x="1176913" y="1966481"/>
              <a:ext cx="1516687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△</a:t>
              </a:r>
              <a:r>
                <a:rPr lang="en-US" altLang="zh-CN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Cupin1-15-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="" xmlns:a16="http://schemas.microsoft.com/office/drawing/2014/main" id="{B5BB1FF1-848D-45A8-BE0F-AA642546BB0B}"/>
                </a:ext>
              </a:extLst>
            </p:cNvPr>
            <p:cNvSpPr txBox="1"/>
            <p:nvPr/>
          </p:nvSpPr>
          <p:spPr>
            <a:xfrm rot="16200000">
              <a:off x="1919247" y="1962954"/>
              <a:ext cx="15477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△</a:t>
              </a:r>
              <a:r>
                <a:rPr lang="en-US" altLang="zh-CN" sz="12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Cupin1</a:t>
              </a:r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9-com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="" xmlns:a16="http://schemas.microsoft.com/office/drawing/2014/main" id="{F470086E-349E-49B0-89AC-2B1007D18E4E}"/>
                </a:ext>
              </a:extLst>
            </p:cNvPr>
            <p:cNvSpPr txBox="1"/>
            <p:nvPr/>
          </p:nvSpPr>
          <p:spPr>
            <a:xfrm>
              <a:off x="248891" y="3402962"/>
              <a:ext cx="7677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0 </a:t>
              </a:r>
              <a:r>
                <a:rPr lang="en-US" altLang="zh-CN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p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="" xmlns:a16="http://schemas.microsoft.com/office/drawing/2014/main" id="{26952E09-4508-4F36-9D50-591464CE5AF3}"/>
                </a:ext>
              </a:extLst>
            </p:cNvPr>
            <p:cNvSpPr txBox="1"/>
            <p:nvPr/>
          </p:nvSpPr>
          <p:spPr>
            <a:xfrm rot="16200000">
              <a:off x="774501" y="2190274"/>
              <a:ext cx="101235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DNA marker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="" xmlns:a16="http://schemas.microsoft.com/office/drawing/2014/main" id="{EB13FDD9-9C93-4C20-9997-2609DC6D9A98}"/>
                </a:ext>
              </a:extLst>
            </p:cNvPr>
            <p:cNvSpPr txBox="1"/>
            <p:nvPr/>
          </p:nvSpPr>
          <p:spPr>
            <a:xfrm rot="16200000">
              <a:off x="3029937" y="2286697"/>
              <a:ext cx="68546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</a:t>
              </a:r>
              <a:r>
                <a:rPr lang="en-US" altLang="zh-CN" sz="1200" baseline="-250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            </a:t>
              </a:r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lang="zh-CN" altLang="en-US" sz="1200" dirty="0"/>
            </a:p>
          </p:txBody>
        </p:sp>
      </p:grpSp>
      <p:sp>
        <p:nvSpPr>
          <p:cNvPr id="13" name="文本框 26">
            <a:extLst>
              <a:ext uri="{FF2B5EF4-FFF2-40B4-BE49-F238E27FC236}">
                <a16:creationId xmlns="" xmlns:a16="http://schemas.microsoft.com/office/drawing/2014/main" id="{ACED0905-85BD-4CEA-9ED7-A89D2DF57F6C}"/>
              </a:ext>
            </a:extLst>
          </p:cNvPr>
          <p:cNvSpPr txBox="1"/>
          <p:nvPr/>
        </p:nvSpPr>
        <p:spPr>
          <a:xfrm>
            <a:off x="633276" y="5071173"/>
            <a:ext cx="706700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3. 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CR confirmation of </a:t>
            </a:r>
            <a:r>
              <a:rPr lang="en-US" altLang="zh-CN" sz="1600" i="1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600" dirty="0" smtClean="0"/>
              <a:t>complementation strains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altLang="zh-CN" sz="1600" dirty="0" smtClean="0"/>
              <a:t>The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600" dirty="0" smtClean="0"/>
              <a:t> gene fragment was used as a probe.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9-com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-com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/>
              <a:t>complementation strains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zh-CN" altLang="zh-CN" sz="1600" b="1" kern="100" dirty="0"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3957515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文本框 22">
            <a:extLst>
              <a:ext uri="{FF2B5EF4-FFF2-40B4-BE49-F238E27FC236}">
                <a16:creationId xmlns="" xmlns:a16="http://schemas.microsoft.com/office/drawing/2014/main" id="{2CE96B1C-D3B3-18BA-D6C8-12647F71860D}"/>
              </a:ext>
            </a:extLst>
          </p:cNvPr>
          <p:cNvSpPr txBox="1"/>
          <p:nvPr/>
        </p:nvSpPr>
        <p:spPr>
          <a:xfrm>
            <a:off x="451177" y="5547894"/>
            <a:ext cx="7387898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igure </a:t>
            </a:r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S4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 M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orphology of </a:t>
            </a:r>
            <a:r>
              <a:rPr lang="en-US" altLang="zh-CN" sz="1600" dirty="0" err="1" smtClean="0">
                <a:latin typeface="Times New Roman" pitchFamily="18" charset="0"/>
                <a:cs typeface="Times New Roman" pitchFamily="18" charset="0"/>
              </a:rPr>
              <a:t>hyphae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(A) and 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nidia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(B) of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deletion mutant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sz="1600" dirty="0" smtClean="0"/>
              <a:t>complementation strain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c TR4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the wide-type strain;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; </a:t>
            </a:r>
            <a:r>
              <a:rPr lang="zh-CN" altLang="en-US" sz="1600" dirty="0" smtClean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600" i="1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600" dirty="0" smtClean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com,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/>
              <a:t>complementation strain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Bars, 10 </a:t>
            </a:r>
            <a:r>
              <a:rPr lang="en-US" altLang="zh-CN" sz="16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m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="" xmlns:a16="http://schemas.microsoft.com/office/drawing/2014/main" id="{2BFBFCAC-6831-4A2C-96A4-8A2425F4CEF9}"/>
              </a:ext>
            </a:extLst>
          </p:cNvPr>
          <p:cNvSpPr txBox="1"/>
          <p:nvPr/>
        </p:nvSpPr>
        <p:spPr>
          <a:xfrm>
            <a:off x="3477441" y="877238"/>
            <a:ext cx="12844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kumimoji="0" lang="en-US" altLang="zh-CN" sz="12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5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1D83151A-0ECF-4BB9-9F89-4406FE59280E}"/>
              </a:ext>
            </a:extLst>
          </p:cNvPr>
          <p:cNvSpPr txBox="1"/>
          <p:nvPr/>
        </p:nvSpPr>
        <p:spPr>
          <a:xfrm>
            <a:off x="4686300" y="881849"/>
            <a:ext cx="13144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kumimoji="0" lang="en-US" altLang="zh-CN" sz="12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kumimoji="0" lang="en-US" altLang="zh-CN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com</a:t>
            </a:r>
            <a:endParaRPr lang="zh-CN" altLang="en-US" sz="1200" dirty="0"/>
          </a:p>
        </p:txBody>
      </p:sp>
      <p:sp>
        <p:nvSpPr>
          <p:cNvPr id="24" name="文本框 23">
            <a:extLst>
              <a:ext uri="{FF2B5EF4-FFF2-40B4-BE49-F238E27FC236}">
                <a16:creationId xmlns="" xmlns:a16="http://schemas.microsoft.com/office/drawing/2014/main" id="{B2CBC8E7-A630-4F08-99E9-46838B1697F4}"/>
              </a:ext>
            </a:extLst>
          </p:cNvPr>
          <p:cNvSpPr txBox="1"/>
          <p:nvPr/>
        </p:nvSpPr>
        <p:spPr>
          <a:xfrm>
            <a:off x="2519169" y="899984"/>
            <a:ext cx="8223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20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 TR4</a:t>
            </a:r>
            <a:endParaRPr lang="zh-CN" altLang="en-US" sz="1200" dirty="0"/>
          </a:p>
        </p:txBody>
      </p:sp>
      <p:sp>
        <p:nvSpPr>
          <p:cNvPr id="46" name="文本框 26">
            <a:extLst>
              <a:ext uri="{FF2B5EF4-FFF2-40B4-BE49-F238E27FC236}">
                <a16:creationId xmlns="" xmlns:a16="http://schemas.microsoft.com/office/drawing/2014/main" id="{FD2D9F91-0B56-4ABB-9BC8-067C3A87DBA6}"/>
              </a:ext>
            </a:extLst>
          </p:cNvPr>
          <p:cNvSpPr txBox="1"/>
          <p:nvPr/>
        </p:nvSpPr>
        <p:spPr>
          <a:xfrm>
            <a:off x="1870007" y="834735"/>
            <a:ext cx="3390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b="1" dirty="0"/>
          </a:p>
        </p:txBody>
      </p:sp>
      <p:sp>
        <p:nvSpPr>
          <p:cNvPr id="47" name="文本框 27">
            <a:extLst>
              <a:ext uri="{FF2B5EF4-FFF2-40B4-BE49-F238E27FC236}">
                <a16:creationId xmlns="" xmlns:a16="http://schemas.microsoft.com/office/drawing/2014/main" id="{B0AA7695-DDC4-49F8-B000-E3E404EC435A}"/>
              </a:ext>
            </a:extLst>
          </p:cNvPr>
          <p:cNvSpPr txBox="1"/>
          <p:nvPr/>
        </p:nvSpPr>
        <p:spPr>
          <a:xfrm>
            <a:off x="1888387" y="3075828"/>
            <a:ext cx="339093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b="1" dirty="0"/>
          </a:p>
        </p:txBody>
      </p:sp>
      <p:sp>
        <p:nvSpPr>
          <p:cNvPr id="48" name="文本框 21">
            <a:extLst>
              <a:ext uri="{FF2B5EF4-FFF2-40B4-BE49-F238E27FC236}">
                <a16:creationId xmlns="" xmlns:a16="http://schemas.microsoft.com/office/drawing/2014/main" id="{2BFBFCAC-6831-4A2C-96A4-8A2425F4CEF9}"/>
              </a:ext>
            </a:extLst>
          </p:cNvPr>
          <p:cNvSpPr txBox="1"/>
          <p:nvPr/>
        </p:nvSpPr>
        <p:spPr>
          <a:xfrm>
            <a:off x="3420291" y="3163238"/>
            <a:ext cx="128448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kumimoji="0" lang="en-US" altLang="zh-CN" sz="12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5</a:t>
            </a:r>
            <a:endParaRPr lang="zh-CN" altLang="en-US" sz="1200" dirty="0"/>
          </a:p>
        </p:txBody>
      </p:sp>
      <p:sp>
        <p:nvSpPr>
          <p:cNvPr id="49" name="文本框 22">
            <a:extLst>
              <a:ext uri="{FF2B5EF4-FFF2-40B4-BE49-F238E27FC236}">
                <a16:creationId xmlns="" xmlns:a16="http://schemas.microsoft.com/office/drawing/2014/main" id="{1D83151A-0ECF-4BB9-9F89-4406FE59280E}"/>
              </a:ext>
            </a:extLst>
          </p:cNvPr>
          <p:cNvSpPr txBox="1"/>
          <p:nvPr/>
        </p:nvSpPr>
        <p:spPr>
          <a:xfrm>
            <a:off x="4638675" y="3167849"/>
            <a:ext cx="13144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zh-CN" altLang="en-US" sz="12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kumimoji="0" lang="en-US" altLang="zh-CN" sz="120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kumimoji="0" lang="en-US" altLang="zh-CN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com</a:t>
            </a:r>
            <a:endParaRPr lang="zh-CN" altLang="en-US" sz="1200" dirty="0"/>
          </a:p>
        </p:txBody>
      </p:sp>
      <p:sp>
        <p:nvSpPr>
          <p:cNvPr id="50" name="文本框 23">
            <a:extLst>
              <a:ext uri="{FF2B5EF4-FFF2-40B4-BE49-F238E27FC236}">
                <a16:creationId xmlns="" xmlns:a16="http://schemas.microsoft.com/office/drawing/2014/main" id="{B2CBC8E7-A630-4F08-99E9-46838B1697F4}"/>
              </a:ext>
            </a:extLst>
          </p:cNvPr>
          <p:cNvSpPr txBox="1"/>
          <p:nvPr/>
        </p:nvSpPr>
        <p:spPr>
          <a:xfrm>
            <a:off x="2471544" y="3185984"/>
            <a:ext cx="8223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0" lang="en-US" altLang="zh-CN" sz="120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 TR4</a:t>
            </a:r>
            <a:endParaRPr lang="zh-CN" altLang="en-US" sz="1200" dirty="0"/>
          </a:p>
        </p:txBody>
      </p:sp>
      <p:pic>
        <p:nvPicPr>
          <p:cNvPr id="2050" name="Picture 2" descr="C:\Users\yunfengli\Desktop\Figure S4-1.jpg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93924" y="1120775"/>
            <a:ext cx="3779759" cy="1984375"/>
          </a:xfrm>
          <a:prstGeom prst="rect">
            <a:avLst/>
          </a:prstGeom>
          <a:noFill/>
        </p:spPr>
      </p:pic>
      <p:pic>
        <p:nvPicPr>
          <p:cNvPr id="2051" name="Picture 3" descr="C:\Users\yunfengli\Desktop\Figure S4-2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165349" y="3424238"/>
            <a:ext cx="3780000" cy="199444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011919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文本框 77">
            <a:extLst>
              <a:ext uri="{FF2B5EF4-FFF2-40B4-BE49-F238E27FC236}">
                <a16:creationId xmlns="" xmlns:a16="http://schemas.microsoft.com/office/drawing/2014/main" id="{51C383F3-260C-417E-B1EB-90A244A5EACD}"/>
              </a:ext>
            </a:extLst>
          </p:cNvPr>
          <p:cNvSpPr txBox="1"/>
          <p:nvPr/>
        </p:nvSpPr>
        <p:spPr>
          <a:xfrm>
            <a:off x="278334" y="6812512"/>
            <a:ext cx="7713141" cy="2062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igure </a:t>
            </a:r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S5.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lony morphology (A) and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growth inhibi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rate (B) of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mutant and </a:t>
            </a:r>
            <a:r>
              <a:rPr lang="en-US" altLang="zh-CN" sz="1600" dirty="0" smtClean="0"/>
              <a:t>complementation strain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ifferent stresses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 </a:t>
            </a:r>
          </a:p>
          <a:p>
            <a:pPr algn="ctr"/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Photographs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were taken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5 d after incubation.  Growth inhibition =(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diameter of untreated strain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-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diameter of treated strain) / (diameter of untreated strain) × 100%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c4, the wide-type strain;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; </a:t>
            </a:r>
            <a:r>
              <a:rPr lang="zh-CN" altLang="en-US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</a:t>
            </a:r>
            <a:r>
              <a:rPr lang="en-US" altLang="zh-CN" sz="1600" i="1" dirty="0" smtClean="0">
                <a:solidFill>
                  <a:prstClr val="black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-com,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mplementation strain.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Values are the means (±SE) based on three independent experiments and bars indicate standard deviations. The same letter are not significantly different at </a:t>
            </a:r>
            <a:r>
              <a:rPr lang="en-US" altLang="zh-CN" sz="1600" i="1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P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&lt;0.05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by Duncan’ s multiple range test. </a:t>
            </a:r>
            <a:endParaRPr lang="zh-CN" altLang="zh-CN" sz="1600" kern="100" dirty="0">
              <a:effectLst/>
              <a:latin typeface="Times New Roman" pitchFamily="18" charset="0"/>
              <a:ea typeface="等线" panose="02010600030101010101" pitchFamily="2" charset="-122"/>
              <a:cs typeface="Times New Roman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="" xmlns:a16="http://schemas.microsoft.com/office/drawing/2014/main" id="{469A9172-1DFE-416E-8F07-717D297655B4}"/>
              </a:ext>
            </a:extLst>
          </p:cNvPr>
          <p:cNvSpPr txBox="1"/>
          <p:nvPr/>
        </p:nvSpPr>
        <p:spPr>
          <a:xfrm>
            <a:off x="4257827" y="2069541"/>
            <a:ext cx="39908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B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4" name="组合 63"/>
          <p:cNvGrpSpPr/>
          <p:nvPr/>
        </p:nvGrpSpPr>
        <p:grpSpPr>
          <a:xfrm>
            <a:off x="735517" y="1842430"/>
            <a:ext cx="3455485" cy="4693761"/>
            <a:chOff x="735517" y="1842430"/>
            <a:chExt cx="3455485" cy="4693761"/>
          </a:xfrm>
        </p:grpSpPr>
        <p:sp>
          <p:nvSpPr>
            <p:cNvPr id="34" name="文本框 33">
              <a:extLst>
                <a:ext uri="{FF2B5EF4-FFF2-40B4-BE49-F238E27FC236}">
                  <a16:creationId xmlns="" xmlns:a16="http://schemas.microsoft.com/office/drawing/2014/main" id="{1D73C143-FAB9-4D43-9375-CAE7119E789E}"/>
                </a:ext>
              </a:extLst>
            </p:cNvPr>
            <p:cNvSpPr txBox="1"/>
            <p:nvPr/>
          </p:nvSpPr>
          <p:spPr>
            <a:xfrm>
              <a:off x="856703" y="1982567"/>
              <a:ext cx="276783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="" xmlns:a16="http://schemas.microsoft.com/office/drawing/2014/main" id="{0C38EC07-2BFA-4711-93DB-978E422F9C73}"/>
                </a:ext>
              </a:extLst>
            </p:cNvPr>
            <p:cNvSpPr txBox="1"/>
            <p:nvPr/>
          </p:nvSpPr>
          <p:spPr>
            <a:xfrm>
              <a:off x="978237" y="3097209"/>
              <a:ext cx="809791" cy="479738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 mol/L</a:t>
              </a:r>
            </a:p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NaCl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="" xmlns:a16="http://schemas.microsoft.com/office/drawing/2014/main" id="{6BD44E7B-2166-4F7A-B9DE-8E84DE6C3F97}"/>
                </a:ext>
              </a:extLst>
            </p:cNvPr>
            <p:cNvSpPr txBox="1"/>
            <p:nvPr/>
          </p:nvSpPr>
          <p:spPr>
            <a:xfrm rot="18900000">
              <a:off x="1678478" y="1983845"/>
              <a:ext cx="9121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c TR4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="" xmlns:a16="http://schemas.microsoft.com/office/drawing/2014/main" id="{CB0069DA-0A9D-41D2-A1B8-8B92D88CDD7E}"/>
                </a:ext>
              </a:extLst>
            </p:cNvPr>
            <p:cNvSpPr txBox="1"/>
            <p:nvPr/>
          </p:nvSpPr>
          <p:spPr>
            <a:xfrm>
              <a:off x="1138154" y="2583968"/>
              <a:ext cx="5602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PDA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="" xmlns:a16="http://schemas.microsoft.com/office/drawing/2014/main" id="{D78FADB3-C37B-470F-A224-B90AC9166767}"/>
                </a:ext>
              </a:extLst>
            </p:cNvPr>
            <p:cNvSpPr txBox="1"/>
            <p:nvPr/>
          </p:nvSpPr>
          <p:spPr>
            <a:xfrm>
              <a:off x="920105" y="3676692"/>
              <a:ext cx="809792" cy="479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 mol/L Sorbitol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="" xmlns:a16="http://schemas.microsoft.com/office/drawing/2014/main" id="{3E74DFAE-0CB3-40FF-807D-0F6F01EE4CF6}"/>
                </a:ext>
              </a:extLst>
            </p:cNvPr>
            <p:cNvSpPr txBox="1"/>
            <p:nvPr/>
          </p:nvSpPr>
          <p:spPr>
            <a:xfrm>
              <a:off x="1020964" y="4261018"/>
              <a:ext cx="767066" cy="4797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.05% SDS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="" xmlns:a16="http://schemas.microsoft.com/office/drawing/2014/main" id="{E0759ADF-6255-4116-A018-12F1267FF2CF}"/>
                </a:ext>
              </a:extLst>
            </p:cNvPr>
            <p:cNvSpPr txBox="1"/>
            <p:nvPr/>
          </p:nvSpPr>
          <p:spPr>
            <a:xfrm>
              <a:off x="812780" y="4840819"/>
              <a:ext cx="995391" cy="461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00 </a:t>
              </a:r>
              <a:r>
                <a:rPr lang="en-US" altLang="zh-CN" sz="1200" dirty="0" err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μg</a:t>
              </a:r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/mL</a:t>
              </a:r>
            </a:p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 CR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="" xmlns:a16="http://schemas.microsoft.com/office/drawing/2014/main" id="{95495BAF-7BA1-466B-A65E-E97E05E1DDBE}"/>
                </a:ext>
              </a:extLst>
            </p:cNvPr>
            <p:cNvSpPr txBox="1"/>
            <p:nvPr/>
          </p:nvSpPr>
          <p:spPr>
            <a:xfrm>
              <a:off x="735517" y="6019889"/>
              <a:ext cx="1053883" cy="479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300 mmol/L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  </a:t>
              </a:r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H</a:t>
              </a:r>
              <a:r>
                <a:rPr lang="en-US" altLang="zh-CN" sz="1200" baseline="-250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O</a:t>
              </a:r>
              <a:r>
                <a:rPr lang="en-US" altLang="zh-CN" sz="1200" baseline="-250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2</a:t>
              </a:r>
              <a:endParaRPr lang="zh-CN" altLang="en-US" sz="1200" baseline="-250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="" xmlns:a16="http://schemas.microsoft.com/office/drawing/2014/main" id="{25197129-8466-4CD9-B4A7-0E7AB3DE059C}"/>
                </a:ext>
              </a:extLst>
            </p:cNvPr>
            <p:cNvSpPr txBox="1"/>
            <p:nvPr/>
          </p:nvSpPr>
          <p:spPr>
            <a:xfrm rot="18900000">
              <a:off x="2190580" y="1898629"/>
              <a:ext cx="12444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△</a:t>
              </a:r>
              <a:r>
                <a:rPr lang="en-US" altLang="zh-C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Cupin1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15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="" xmlns:a16="http://schemas.microsoft.com/office/drawing/2014/main" id="{941BA094-6D8B-4ED6-B330-53AA10B9A4B5}"/>
                </a:ext>
              </a:extLst>
            </p:cNvPr>
            <p:cNvSpPr txBox="1"/>
            <p:nvPr/>
          </p:nvSpPr>
          <p:spPr>
            <a:xfrm rot="18900000">
              <a:off x="2766613" y="1842430"/>
              <a:ext cx="14243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△</a:t>
              </a:r>
              <a:r>
                <a:rPr lang="en-US" altLang="zh-CN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Cupin1</a:t>
              </a:r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com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="" xmlns:a16="http://schemas.microsoft.com/office/drawing/2014/main" id="{40F31AF3-6FA2-45A6-98D7-37F2F9F90AD4}"/>
                </a:ext>
              </a:extLst>
            </p:cNvPr>
            <p:cNvSpPr txBox="1"/>
            <p:nvPr/>
          </p:nvSpPr>
          <p:spPr>
            <a:xfrm>
              <a:off x="775663" y="5428449"/>
              <a:ext cx="950512" cy="4797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1</a:t>
              </a:r>
              <a:r>
                <a:rPr lang="el-GR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00</a:t>
              </a:r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l-GR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μ</a:t>
              </a:r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/mL</a:t>
              </a:r>
            </a:p>
            <a:p>
              <a:r>
                <a:rPr lang="en-US" altLang="zh-CN" sz="12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  CFW</a:t>
              </a:r>
              <a:endParaRPr lang="zh-CN" altLang="en-US" sz="12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3074" name="Picture 2" descr="C:\Users\yunfengli\Desktop\Figure S5.jp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597024" y="2462212"/>
              <a:ext cx="1755775" cy="4073979"/>
            </a:xfrm>
            <a:prstGeom prst="rect">
              <a:avLst/>
            </a:prstGeom>
            <a:noFill/>
          </p:spPr>
        </p:pic>
      </p:grp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/>
          <a:srcRect l="6279" t="5292" r="11282" b="4750"/>
          <a:stretch>
            <a:fillRect/>
          </a:stretch>
        </p:blipFill>
        <p:spPr bwMode="auto">
          <a:xfrm>
            <a:off x="3829050" y="2638425"/>
            <a:ext cx="3876675" cy="32385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="" xmlns:p14="http://schemas.microsoft.com/office/powerpoint/2010/main" val="21048392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="" xmlns:a16="http://schemas.microsoft.com/office/drawing/2014/main" id="{1DB1142E-986B-FE69-C10A-872D96F740AE}"/>
              </a:ext>
            </a:extLst>
          </p:cNvPr>
          <p:cNvSpPr txBox="1"/>
          <p:nvPr/>
        </p:nvSpPr>
        <p:spPr>
          <a:xfrm>
            <a:off x="335881" y="5709166"/>
            <a:ext cx="7569176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600" b="1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6</a:t>
            </a:r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of fusaric acid </a:t>
            </a:r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ents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zh-CN" sz="1600" dirty="0">
                <a:effectLst/>
                <a:latin typeface="Arial" panose="020B0604020202020204" pitchFamily="34" charset="0"/>
              </a:rPr>
              <a:t> </a:t>
            </a:r>
            <a:endParaRPr lang="en-US" altLang="zh-CN" sz="1600" dirty="0" smtClean="0">
              <a:effectLst/>
              <a:latin typeface="Arial" panose="020B0604020202020204" pitchFamily="34" charset="0"/>
            </a:endParaRPr>
          </a:p>
          <a:p>
            <a:pPr algn="ctr"/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c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R4, the wide-type strain;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; </a:t>
            </a:r>
            <a:r>
              <a:rPr lang="zh-CN" altLang="en-US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</a:t>
            </a:r>
            <a:r>
              <a:rPr lang="en-US" altLang="zh-CN" sz="1600" i="1" dirty="0" smtClean="0">
                <a:solidFill>
                  <a:prstClr val="black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-com,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mplementation strain.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Values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are the means (±SE) based on three independent experiments and bars indicate standard deviations. The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letters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are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significantly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different at </a:t>
            </a:r>
            <a:r>
              <a:rPr lang="en-US" altLang="zh-CN" sz="1600" i="1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P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&lt;0.05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by Duncan’ s multiple range test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/>
          <a:srcRect l="6077" t="6615" r="11687" b="7131"/>
          <a:stretch>
            <a:fillRect/>
          </a:stretch>
        </p:blipFill>
        <p:spPr bwMode="auto">
          <a:xfrm>
            <a:off x="1771649" y="2307818"/>
            <a:ext cx="4219575" cy="3388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="" xmlns:p14="http://schemas.microsoft.com/office/powerpoint/2010/main" val="95404486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文本框 18">
            <a:extLst>
              <a:ext uri="{FF2B5EF4-FFF2-40B4-BE49-F238E27FC236}">
                <a16:creationId xmlns="" xmlns:a16="http://schemas.microsoft.com/office/drawing/2014/main" id="{AFE578C8-ECDE-473E-B826-4CD814C949BC}"/>
              </a:ext>
            </a:extLst>
          </p:cNvPr>
          <p:cNvSpPr txBox="1"/>
          <p:nvPr/>
        </p:nvSpPr>
        <p:spPr>
          <a:xfrm>
            <a:off x="236009" y="5430041"/>
            <a:ext cx="7790392" cy="25545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600" b="1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igure S7.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P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enetration and colonization assay of 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deletion mutant and complementation strain.</a:t>
            </a:r>
            <a:endParaRPr lang="en-US" altLang="zh-CN" sz="1600" kern="0" dirty="0" smtClean="0">
              <a:solidFill>
                <a:srgbClr val="000000"/>
              </a:solidFill>
              <a:effectLst/>
              <a:latin typeface="Times New Roman" pitchFamily="18" charset="0"/>
              <a:ea typeface="等线" panose="02010600030101010101" pitchFamily="2" charset="-122"/>
              <a:cs typeface="Times New Roman" pitchFamily="18" charset="0"/>
            </a:endParaRPr>
          </a:p>
          <a:p>
            <a:pPr algn="ctr">
              <a:buAutoNum type="alphaUcParenBoth"/>
            </a:pP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Cellophane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penetration assay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Autoclaved cellophane sheets were placed on PDA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plates,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and </a:t>
            </a:r>
            <a:r>
              <a:rPr lang="en-US" altLang="zh-CN" sz="1600" kern="100" dirty="0" smtClean="0"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5-mm 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diameter mycelium plugs were then inoculated on the plates for 3 d at 28</a:t>
            </a:r>
            <a:r>
              <a:rPr lang="en-US" altLang="zh-CN" sz="1600" kern="100" dirty="0" smtClean="0">
                <a:solidFill>
                  <a:srgbClr val="333333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℃ (a)</a:t>
            </a:r>
            <a:r>
              <a:rPr lang="en-US" altLang="zh-CN" sz="1600" kern="100" dirty="0" smtClean="0"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The </a:t>
            </a:r>
            <a:r>
              <a:rPr lang="en-US" altLang="zh-CN" sz="1600" kern="0" dirty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cellophane sheets with the fungal colony were </a:t>
            </a:r>
            <a:r>
              <a:rPr lang="en-US" altLang="zh-CN" sz="1600" kern="0" dirty="0" smtClean="0">
                <a:solidFill>
                  <a:srgbClr val="000000"/>
                </a:solidFill>
                <a:effectLst/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removed and then incubated continually for another 3 d (b)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(B) Colonization assay on tomato fruit.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resh tomato were inoculated with 5-mm diameter mycelium plugs and incubated at 28˚C under 90% humidity for 3 d.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(C)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Fresh apple were inoculated with 10 </a:t>
            </a:r>
            <a:r>
              <a:rPr lang="en-US" altLang="zh-CN" sz="1600" kern="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μL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conidial suspension (1×10</a:t>
            </a:r>
            <a:r>
              <a:rPr lang="en-US" altLang="zh-CN" sz="1600" kern="0" baseline="3000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5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 conidia/</a:t>
            </a:r>
            <a:r>
              <a:rPr lang="en-US" altLang="zh-CN" sz="1600" kern="0" dirty="0" err="1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mL</a:t>
            </a:r>
            <a:r>
              <a:rPr lang="en-US" altLang="zh-CN" sz="16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) and incubated at 28˚C under 90% humidity for 3 d.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c TR4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the wide-type strain;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-15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, 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deletion mutant; </a:t>
            </a:r>
            <a:r>
              <a:rPr lang="zh-CN" altLang="en-US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△</a:t>
            </a:r>
            <a:r>
              <a:rPr lang="en-US" altLang="zh-CN" sz="1600" i="1" dirty="0" smtClean="0">
                <a:solidFill>
                  <a:prstClr val="black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dirty="0" smtClean="0">
                <a:solidFill>
                  <a:prstClr val="black"/>
                </a:solidFill>
                <a:latin typeface="Times New Roman" pitchFamily="18" charset="0"/>
                <a:ea typeface="宋体" panose="02010600030101010101" pitchFamily="2" charset="-122"/>
                <a:cs typeface="Times New Roman" pitchFamily="18" charset="0"/>
              </a:rPr>
              <a:t>-com, </a:t>
            </a:r>
            <a:r>
              <a:rPr lang="en-US" altLang="zh-CN" sz="1600" i="1" kern="0" dirty="0" smtClean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FoCupin1</a:t>
            </a:r>
            <a:r>
              <a:rPr lang="en-US" altLang="zh-CN" sz="16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complementation strain. </a:t>
            </a:r>
            <a:endParaRPr lang="zh-CN" altLang="zh-CN" sz="1600" kern="100" dirty="0">
              <a:effectLst/>
              <a:latin typeface="Times New Roman" pitchFamily="18" charset="0"/>
              <a:ea typeface="等线" panose="02010600030101010101" pitchFamily="2" charset="-122"/>
              <a:cs typeface="Times New Roman" pitchFamily="18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="" xmlns:a16="http://schemas.microsoft.com/office/drawing/2014/main" id="{1B8BE9B9-0FDB-49BC-BFCD-FD90F7C0A0E9}"/>
              </a:ext>
            </a:extLst>
          </p:cNvPr>
          <p:cNvSpPr txBox="1"/>
          <p:nvPr/>
        </p:nvSpPr>
        <p:spPr>
          <a:xfrm>
            <a:off x="1857375" y="1496735"/>
            <a:ext cx="36121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 </a:t>
            </a:r>
            <a:endParaRPr lang="zh-CN" altLang="en-US" sz="1200" dirty="0"/>
          </a:p>
        </p:txBody>
      </p:sp>
      <p:sp>
        <p:nvSpPr>
          <p:cNvPr id="11" name="文本框 10">
            <a:extLst>
              <a:ext uri="{FF2B5EF4-FFF2-40B4-BE49-F238E27FC236}">
                <a16:creationId xmlns="" xmlns:a16="http://schemas.microsoft.com/office/drawing/2014/main" id="{C5AA7E12-5A66-4B46-BFF1-B8231DC47DAC}"/>
              </a:ext>
            </a:extLst>
          </p:cNvPr>
          <p:cNvSpPr txBox="1"/>
          <p:nvPr/>
        </p:nvSpPr>
        <p:spPr>
          <a:xfrm>
            <a:off x="1857375" y="2522370"/>
            <a:ext cx="40383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/>
            <a:r>
              <a:rPr lang="en-US" altLang="zh-CN" sz="1200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endParaRPr lang="zh-CN" altLang="en-US" sz="1200" dirty="0"/>
          </a:p>
        </p:txBody>
      </p:sp>
      <p:sp>
        <p:nvSpPr>
          <p:cNvPr id="20" name="文本框 19">
            <a:extLst>
              <a:ext uri="{FF2B5EF4-FFF2-40B4-BE49-F238E27FC236}">
                <a16:creationId xmlns="" xmlns:a16="http://schemas.microsoft.com/office/drawing/2014/main" id="{9B6BCDC0-180A-4B15-B1BF-FB235B6261D3}"/>
              </a:ext>
            </a:extLst>
          </p:cNvPr>
          <p:cNvSpPr txBox="1"/>
          <p:nvPr/>
        </p:nvSpPr>
        <p:spPr>
          <a:xfrm>
            <a:off x="3075804" y="823554"/>
            <a:ext cx="119987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5</a:t>
            </a:r>
            <a:endParaRPr lang="zh-CN" altLang="en-US" sz="1200" dirty="0"/>
          </a:p>
        </p:txBody>
      </p:sp>
      <p:sp>
        <p:nvSpPr>
          <p:cNvPr id="21" name="文本框 20">
            <a:extLst>
              <a:ext uri="{FF2B5EF4-FFF2-40B4-BE49-F238E27FC236}">
                <a16:creationId xmlns="" xmlns:a16="http://schemas.microsoft.com/office/drawing/2014/main" id="{8E2AE5DC-2D88-4124-9C3D-28C1AA314EA6}"/>
              </a:ext>
            </a:extLst>
          </p:cNvPr>
          <p:cNvSpPr txBox="1"/>
          <p:nvPr/>
        </p:nvSpPr>
        <p:spPr>
          <a:xfrm>
            <a:off x="4276805" y="818493"/>
            <a:ext cx="127733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zh-CN" altLang="en-US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△</a:t>
            </a:r>
            <a:r>
              <a:rPr lang="en-US" altLang="zh-CN" sz="1200" i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oCupin1</a:t>
            </a:r>
            <a:r>
              <a:rPr lang="en-US" altLang="zh-CN" sz="1200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com</a:t>
            </a:r>
            <a:endParaRPr lang="zh-CN" altLang="en-US" sz="1200" dirty="0"/>
          </a:p>
        </p:txBody>
      </p:sp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68526DC2-7FCF-4B6F-8CC3-18871212AB91}"/>
              </a:ext>
            </a:extLst>
          </p:cNvPr>
          <p:cNvSpPr txBox="1"/>
          <p:nvPr/>
        </p:nvSpPr>
        <p:spPr>
          <a:xfrm>
            <a:off x="2337464" y="827082"/>
            <a:ext cx="7996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 smtClean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oc TR4</a:t>
            </a:r>
            <a:endParaRPr lang="zh-CN" altLang="en-US" sz="1200" dirty="0"/>
          </a:p>
        </p:txBody>
      </p:sp>
      <p:sp>
        <p:nvSpPr>
          <p:cNvPr id="40" name="文本框 23">
            <a:extLst>
              <a:ext uri="{FF2B5EF4-FFF2-40B4-BE49-F238E27FC236}">
                <a16:creationId xmlns="" xmlns:a16="http://schemas.microsoft.com/office/drawing/2014/main" id="{EC453331-161C-439D-A395-653B70C9C495}"/>
              </a:ext>
            </a:extLst>
          </p:cNvPr>
          <p:cNvSpPr txBox="1"/>
          <p:nvPr/>
        </p:nvSpPr>
        <p:spPr>
          <a:xfrm>
            <a:off x="1705439" y="809478"/>
            <a:ext cx="343496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1798570" y="3103940"/>
            <a:ext cx="4226514" cy="1991934"/>
            <a:chOff x="1798570" y="3103940"/>
            <a:chExt cx="4226514" cy="1991934"/>
          </a:xfrm>
        </p:grpSpPr>
        <p:pic>
          <p:nvPicPr>
            <p:cNvPr id="4099" name="Picture 3" descr="C:\Users\yunfengli\Desktop\Figure S7-2.jpg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854200" y="3213099"/>
              <a:ext cx="3978602" cy="1882775"/>
            </a:xfrm>
            <a:prstGeom prst="rect">
              <a:avLst/>
            </a:prstGeom>
            <a:noFill/>
          </p:spPr>
        </p:pic>
        <p:sp>
          <p:nvSpPr>
            <p:cNvPr id="28" name="文本框 21">
              <a:extLst>
                <a:ext uri="{FF2B5EF4-FFF2-40B4-BE49-F238E27FC236}">
                  <a16:creationId xmlns="" xmlns:a16="http://schemas.microsoft.com/office/drawing/2014/main" id="{7D2A4E06-70D6-4956-819E-9D3A09BB7AC1}"/>
                </a:ext>
              </a:extLst>
            </p:cNvPr>
            <p:cNvSpPr txBox="1"/>
            <p:nvPr/>
          </p:nvSpPr>
          <p:spPr>
            <a:xfrm>
              <a:off x="2197077" y="3223646"/>
              <a:ext cx="55458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100" baseline="-250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100" dirty="0" smtClean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endParaRPr lang="zh-CN" altLang="en-US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2">
              <a:extLst>
                <a:ext uri="{FF2B5EF4-FFF2-40B4-BE49-F238E27FC236}">
                  <a16:creationId xmlns="" xmlns:a16="http://schemas.microsoft.com/office/drawing/2014/main" id="{051CAAED-00BC-4800-8CA4-4E446410649B}"/>
                </a:ext>
              </a:extLst>
            </p:cNvPr>
            <p:cNvSpPr txBox="1"/>
            <p:nvPr/>
          </p:nvSpPr>
          <p:spPr>
            <a:xfrm>
              <a:off x="2988255" y="3743042"/>
              <a:ext cx="736020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100" dirty="0" smtClean="0">
                  <a:solidFill>
                    <a:schemeClr val="bg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oc TR4</a:t>
              </a:r>
              <a:endParaRPr lang="zh-CN" altLang="en-US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3">
              <a:extLst>
                <a:ext uri="{FF2B5EF4-FFF2-40B4-BE49-F238E27FC236}">
                  <a16:creationId xmlns="" xmlns:a16="http://schemas.microsoft.com/office/drawing/2014/main" id="{F181B966-6B8C-4E69-AA36-6E30C99AE58C}"/>
                </a:ext>
              </a:extLst>
            </p:cNvPr>
            <p:cNvSpPr txBox="1"/>
            <p:nvPr/>
          </p:nvSpPr>
          <p:spPr>
            <a:xfrm>
              <a:off x="1827022" y="3926479"/>
              <a:ext cx="126332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10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△</a:t>
              </a:r>
              <a:r>
                <a:rPr kumimoji="0" lang="en-US" altLang="zh-CN" sz="1100" i="1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oCupin1</a:t>
              </a:r>
              <a:r>
                <a:rPr kumimoji="0" lang="en-US" altLang="zh-CN" sz="110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15</a:t>
              </a:r>
              <a:endParaRPr lang="zh-CN" altLang="en-US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24">
              <a:extLst>
                <a:ext uri="{FF2B5EF4-FFF2-40B4-BE49-F238E27FC236}">
                  <a16:creationId xmlns="" xmlns:a16="http://schemas.microsoft.com/office/drawing/2014/main" id="{3C074DE5-463B-4927-BF4F-F09DEEC51B36}"/>
                </a:ext>
              </a:extLst>
            </p:cNvPr>
            <p:cNvSpPr txBox="1"/>
            <p:nvPr/>
          </p:nvSpPr>
          <p:spPr>
            <a:xfrm>
              <a:off x="2396055" y="4495799"/>
              <a:ext cx="1312333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0" lang="en-US" altLang="zh-CN" sz="110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△</a:t>
              </a:r>
              <a:r>
                <a:rPr kumimoji="0" lang="en-US" altLang="zh-CN" sz="1100" i="1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FoCupin1</a:t>
              </a:r>
              <a:r>
                <a:rPr kumimoji="0" lang="en-US" altLang="zh-CN" sz="1100" u="none" strike="noStrike" kern="1200" cap="none" spc="0" normalizeH="0" baseline="0" noProof="0" dirty="0">
                  <a:ln>
                    <a:noFill/>
                  </a:ln>
                  <a:solidFill>
                    <a:schemeClr val="bg1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com</a:t>
              </a:r>
              <a:endParaRPr lang="zh-CN" altLang="en-US" sz="11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" name="组合 19">
              <a:extLst>
                <a:ext uri="{FF2B5EF4-FFF2-40B4-BE49-F238E27FC236}">
                  <a16:creationId xmlns="" xmlns:a16="http://schemas.microsoft.com/office/drawing/2014/main" id="{6D84FB14-183E-4518-811B-9A0912C45C33}"/>
                </a:ext>
              </a:extLst>
            </p:cNvPr>
            <p:cNvGrpSpPr/>
            <p:nvPr/>
          </p:nvGrpSpPr>
          <p:grpSpPr>
            <a:xfrm>
              <a:off x="4042932" y="3779378"/>
              <a:ext cx="1982152" cy="1012714"/>
              <a:chOff x="1715930" y="4234493"/>
              <a:chExt cx="2267854" cy="1185570"/>
            </a:xfrm>
          </p:grpSpPr>
          <p:sp>
            <p:nvSpPr>
              <p:cNvPr id="36" name="文本框 21">
                <a:extLst>
                  <a:ext uri="{FF2B5EF4-FFF2-40B4-BE49-F238E27FC236}">
                    <a16:creationId xmlns="" xmlns:a16="http://schemas.microsoft.com/office/drawing/2014/main" id="{754677D3-56F0-4950-9DFC-FBDCFA105DD0}"/>
                  </a:ext>
                </a:extLst>
              </p:cNvPr>
              <p:cNvSpPr txBox="1"/>
              <p:nvPr/>
            </p:nvSpPr>
            <p:spPr>
              <a:xfrm>
                <a:off x="2915567" y="4234493"/>
                <a:ext cx="866008" cy="3062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100" dirty="0" smtClean="0"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oc TR4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22">
                <a:extLst>
                  <a:ext uri="{FF2B5EF4-FFF2-40B4-BE49-F238E27FC236}">
                    <a16:creationId xmlns="" xmlns:a16="http://schemas.microsoft.com/office/drawing/2014/main" id="{7A893EF7-346F-4E7F-8CAB-DEE767B0BB15}"/>
                  </a:ext>
                </a:extLst>
              </p:cNvPr>
              <p:cNvSpPr txBox="1"/>
              <p:nvPr/>
            </p:nvSpPr>
            <p:spPr>
              <a:xfrm>
                <a:off x="1715930" y="4430523"/>
                <a:ext cx="1403391" cy="3062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10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△</a:t>
                </a:r>
                <a:r>
                  <a:rPr kumimoji="0" lang="en-US" altLang="zh-CN" sz="110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oCupin1</a:t>
                </a:r>
                <a:r>
                  <a:rPr kumimoji="0" lang="en-US" altLang="zh-CN" sz="110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15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23">
                <a:extLst>
                  <a:ext uri="{FF2B5EF4-FFF2-40B4-BE49-F238E27FC236}">
                    <a16:creationId xmlns="" xmlns:a16="http://schemas.microsoft.com/office/drawing/2014/main" id="{2EAF750E-6E98-454B-972F-56FB4576802E}"/>
                  </a:ext>
                </a:extLst>
              </p:cNvPr>
              <p:cNvSpPr txBox="1"/>
              <p:nvPr/>
            </p:nvSpPr>
            <p:spPr>
              <a:xfrm>
                <a:off x="2443549" y="5113800"/>
                <a:ext cx="1540235" cy="30626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kumimoji="0" lang="en-US" altLang="zh-CN" sz="110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△</a:t>
                </a:r>
                <a:r>
                  <a:rPr kumimoji="0" lang="en-US" altLang="zh-CN" sz="1100" i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FoCupin1</a:t>
                </a:r>
                <a:r>
                  <a:rPr kumimoji="0" lang="en-US" altLang="zh-CN" sz="110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imes New Roman" panose="02020603050405020304" pitchFamily="18" charset="0"/>
                    <a:ea typeface="宋体" panose="02010600030101010101" pitchFamily="2" charset="-122"/>
                    <a:cs typeface="Times New Roman" panose="02020603050405020304" pitchFamily="18" charset="0"/>
                  </a:rPr>
                  <a:t>-com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9" name="文本框 21">
              <a:extLst>
                <a:ext uri="{FF2B5EF4-FFF2-40B4-BE49-F238E27FC236}">
                  <a16:creationId xmlns="" xmlns:a16="http://schemas.microsoft.com/office/drawing/2014/main" id="{7D2A4E06-70D6-4956-819E-9D3A09BB7AC1}"/>
                </a:ext>
              </a:extLst>
            </p:cNvPr>
            <p:cNvSpPr txBox="1"/>
            <p:nvPr/>
          </p:nvSpPr>
          <p:spPr>
            <a:xfrm>
              <a:off x="4237542" y="3426845"/>
              <a:ext cx="55458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altLang="zh-CN" sz="1100" baseline="-25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zh-CN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23">
              <a:extLst>
                <a:ext uri="{FF2B5EF4-FFF2-40B4-BE49-F238E27FC236}">
                  <a16:creationId xmlns="" xmlns:a16="http://schemas.microsoft.com/office/drawing/2014/main" id="{EC453331-161C-439D-A395-653B70C9C495}"/>
                </a:ext>
              </a:extLst>
            </p:cNvPr>
            <p:cNvSpPr txBox="1"/>
            <p:nvPr/>
          </p:nvSpPr>
          <p:spPr>
            <a:xfrm>
              <a:off x="1798570" y="3120875"/>
              <a:ext cx="34349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23">
              <a:extLst>
                <a:ext uri="{FF2B5EF4-FFF2-40B4-BE49-F238E27FC236}">
                  <a16:creationId xmlns="" xmlns:a16="http://schemas.microsoft.com/office/drawing/2014/main" id="{EC453331-161C-439D-A395-653B70C9C495}"/>
                </a:ext>
              </a:extLst>
            </p:cNvPr>
            <p:cNvSpPr txBox="1"/>
            <p:nvPr/>
          </p:nvSpPr>
          <p:spPr>
            <a:xfrm>
              <a:off x="3839037" y="3103940"/>
              <a:ext cx="343496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4098" name="Picture 2" descr="C:\Users\yunfengli\Desktop\Figure S7-1.jpg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219325" y="1085849"/>
            <a:ext cx="3257550" cy="204787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638618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89</TotalTime>
  <Words>610</Words>
  <Application>Microsoft Office PowerPoint</Application>
  <PresentationFormat>自定义</PresentationFormat>
  <Paragraphs>71</Paragraphs>
  <Slides>7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​​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524612146@qq.com</dc:creator>
  <cp:lastModifiedBy>李云锋</cp:lastModifiedBy>
  <cp:revision>318</cp:revision>
  <cp:lastPrinted>2022-04-01T11:10:00Z</cp:lastPrinted>
  <dcterms:created xsi:type="dcterms:W3CDTF">2022-03-31T07:08:00Z</dcterms:created>
  <dcterms:modified xsi:type="dcterms:W3CDTF">2022-08-11T03:01:38Z</dcterms:modified>
</cp:coreProperties>
</file>